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73152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396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725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866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337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718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132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202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576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367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534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967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626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08E5E1-D77B-4590-8E00-123D6D3232E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7BA973-5EF4-4AAB-90C8-18377A061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878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85237" y="120503"/>
            <a:ext cx="19302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4721" y="640210"/>
            <a:ext cx="2975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184476" y="843015"/>
            <a:ext cx="6598148" cy="1971765"/>
            <a:chOff x="184476" y="457242"/>
            <a:chExt cx="6598148" cy="1971765"/>
          </a:xfrm>
        </p:grpSpPr>
        <p:grpSp>
          <p:nvGrpSpPr>
            <p:cNvPr id="7" name="Group 6"/>
            <p:cNvGrpSpPr/>
            <p:nvPr/>
          </p:nvGrpSpPr>
          <p:grpSpPr>
            <a:xfrm>
              <a:off x="184476" y="764447"/>
              <a:ext cx="6598148" cy="1664560"/>
              <a:chOff x="149034" y="1813526"/>
              <a:chExt cx="6598148" cy="1664560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9034" y="1813527"/>
                <a:ext cx="2184733" cy="1664559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55745" y="1813526"/>
                <a:ext cx="2184735" cy="1664559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62448" y="1813526"/>
                <a:ext cx="2184734" cy="1664559"/>
              </a:xfrm>
              <a:prstGeom prst="rect">
                <a:avLst/>
              </a:prstGeom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945238" y="457242"/>
              <a:ext cx="8009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YPD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45097" y="457242"/>
              <a:ext cx="12618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YNB pH 7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191984" y="457242"/>
              <a:ext cx="9450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YNB-U</a:t>
              </a:r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27793" y="3274780"/>
            <a:ext cx="2975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254" y="3381973"/>
            <a:ext cx="3881331" cy="378973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22253" y="7384412"/>
            <a:ext cx="6735771" cy="14518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6000"/>
              </a:lnSpc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: Growing KN99 in in YPD, YNB-U or in YNB, pH 7 did not significantly affect cell associated capsule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Visualization of the capsule after India ink staining of KN99 grown in three separate media for 48 h.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Representative immunofluorescence micrographs of KN99 after growth in the specified media for 48 h. Anti-GXM monoclonal antibody 18B7 and a goat anti mouse IgG conjugated to Alexa Fluor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egoe UI Emoji" panose="020B0502040204020203" pitchFamily="34" charset="0"/>
              </a:rPr>
              <a:t>™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lus 555 were used to stain the capsule.</a:t>
            </a:r>
          </a:p>
        </p:txBody>
      </p:sp>
    </p:spTree>
    <p:extLst>
      <p:ext uri="{BB962C8B-B14F-4D97-AF65-F5344CB8AC3E}">
        <p14:creationId xmlns:p14="http://schemas.microsoft.com/office/powerpoint/2010/main" val="3706514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196" y="669533"/>
            <a:ext cx="6440504" cy="465221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5237" y="120503"/>
            <a:ext cx="19302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sp>
        <p:nvSpPr>
          <p:cNvPr id="3" name="Rectangle 2"/>
          <p:cNvSpPr/>
          <p:nvPr/>
        </p:nvSpPr>
        <p:spPr>
          <a:xfrm>
            <a:off x="303196" y="5321745"/>
            <a:ext cx="629762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: KN99 grown in YNB-U causes a major inflammatory response in murine lun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BA/J mice were inoculated intranasally with 10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K CFU of KN99 that had been cultured in three separate media for 48 h. At 3 DPI, the lungs were perfused, harvested, embedded, sectioned, and processed for hematoxylin and eosin staining. Images are representative of two independent experiments using three mice per group.</a:t>
            </a:r>
          </a:p>
        </p:txBody>
      </p:sp>
    </p:spTree>
    <p:extLst>
      <p:ext uri="{BB962C8B-B14F-4D97-AF65-F5344CB8AC3E}">
        <p14:creationId xmlns:p14="http://schemas.microsoft.com/office/powerpoint/2010/main" val="5743814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5237" y="120503"/>
            <a:ext cx="19302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650" y="567849"/>
            <a:ext cx="6850031" cy="54800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85237" y="6149188"/>
            <a:ext cx="7037513" cy="21370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6000"/>
              </a:lnSpc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3: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grown in YNB-U induces a dramatic hyper-inflammatory response in the lung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bsolute levels of cytokine and chemokines in the lungs of mice at 3, 5 and 7 DPI. CBA/J mice were inoculated with indicated innoculum doses of HK KN99 cells grown in either in YPD, YNB-U or YNB pH 7 for 48 h. Lung homogenates were prepared and the cytokine/chemokine responses were determined using the Bio-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ex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array system (Bio-Rad, USA). Data are representative of a minimum of two experiments with three animals each. All data are presented as mean values ± standard errors of the means (SEM). ns, not significant; ****, p&lt;0.0001; **p&lt;0.005 and *p&lt;0.02 as determined by one-way ANOVA with Dunnett's multiple comparisons test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9689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0</TotalTime>
  <Words>329</Words>
  <Application>Microsoft Office PowerPoint</Application>
  <PresentationFormat>Custom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egoe UI Emoj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ndra upadhya</dc:creator>
  <cp:lastModifiedBy>Rajendra Upadhya</cp:lastModifiedBy>
  <cp:revision>15</cp:revision>
  <dcterms:created xsi:type="dcterms:W3CDTF">2021-04-22T19:33:21Z</dcterms:created>
  <dcterms:modified xsi:type="dcterms:W3CDTF">2023-03-08T19:02:28Z</dcterms:modified>
</cp:coreProperties>
</file>